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3108325" cy="15128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77" userDrawn="1">
          <p15:clr>
            <a:srgbClr val="A4A3A4"/>
          </p15:clr>
        </p15:guide>
        <p15:guide id="2" pos="97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162" autoAdjust="0"/>
    <p:restoredTop sz="94660"/>
  </p:normalViewPr>
  <p:slideViewPr>
    <p:cSldViewPr snapToGrid="0" showGuides="1">
      <p:cViewPr>
        <p:scale>
          <a:sx n="300" d="100"/>
          <a:sy n="300" d="100"/>
        </p:scale>
        <p:origin x="276" y="216"/>
      </p:cViewPr>
      <p:guideLst>
        <p:guide orient="horz" pos="477"/>
        <p:guide pos="97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freitz\Box\Current%20S%20drive\BER%20project\Dissertation\Chapter%20Disc%20Methods\Data%20files\AO%20whole%20frui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468227898905953"/>
          <c:y val="6.2798960473465018E-2"/>
          <c:w val="0.87796333606895072"/>
          <c:h val="0.8282558773916434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Plate 1 - Sheet1'!$K$88</c:f>
              <c:strCache>
                <c:ptCount val="1"/>
                <c:pt idx="0">
                  <c:v>BER-unaffected fruit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Lbls>
            <c:dLbl>
              <c:idx val="0"/>
              <c:layout>
                <c:manualLayout>
                  <c:x val="-1.9371520462042277E-17"/>
                  <c:y val="-5.0872748029682446E-2"/>
                </c:manualLayout>
              </c:layout>
              <c:tx>
                <c:rich>
                  <a:bodyPr/>
                  <a:lstStyle/>
                  <a:p>
                    <a:fld id="{BD4D8523-88D4-4B56-A4F1-F2890A7AB20C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0-B8F1-4717-984B-74820E3DE1C0}"/>
                </c:ext>
              </c:extLst>
            </c:dLbl>
            <c:dLbl>
              <c:idx val="1"/>
              <c:layout>
                <c:manualLayout>
                  <c:x val="-7.7486081848169108E-17"/>
                  <c:y val="-3.8154561022261911E-2"/>
                </c:manualLayout>
              </c:layout>
              <c:tx>
                <c:rich>
                  <a:bodyPr/>
                  <a:lstStyle/>
                  <a:p>
                    <a:fld id="{F1D580E5-103A-4F6B-BF24-AD82F3DBB31E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1-B8F1-4717-984B-74820E3DE1C0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B8F1-4717-984B-74820E3DE1C0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Plate 1 - Sheet1'!$M$89:$M$90</c:f>
                <c:numCache>
                  <c:formatCode>General</c:formatCode>
                  <c:ptCount val="2"/>
                  <c:pt idx="0">
                    <c:v>89.297918295583571</c:v>
                  </c:pt>
                  <c:pt idx="1">
                    <c:v>80.736809506617973</c:v>
                  </c:pt>
                </c:numCache>
              </c:numRef>
            </c:plus>
            <c:minus>
              <c:numRef>
                <c:f>'Plate 1 - Sheet1'!$M$89:$M$90</c:f>
                <c:numCache>
                  <c:formatCode>General</c:formatCode>
                  <c:ptCount val="2"/>
                  <c:pt idx="0">
                    <c:v>89.297918295583571</c:v>
                  </c:pt>
                  <c:pt idx="1">
                    <c:v>80.73680950661797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late 1 - Sheet1'!$J$89:$J$91</c:f>
              <c:strCache>
                <c:ptCount val="3"/>
                <c:pt idx="0">
                  <c:v>Stem-end</c:v>
                </c:pt>
                <c:pt idx="1">
                  <c:v>Blossom-end</c:v>
                </c:pt>
                <c:pt idx="2">
                  <c:v>BER tissue</c:v>
                </c:pt>
              </c:strCache>
            </c:strRef>
          </c:cat>
          <c:val>
            <c:numRef>
              <c:f>'Plate 1 - Sheet1'!$K$89:$K$91</c:f>
              <c:numCache>
                <c:formatCode>General</c:formatCode>
                <c:ptCount val="3"/>
                <c:pt idx="0">
                  <c:v>280.58831412489963</c:v>
                </c:pt>
                <c:pt idx="1">
                  <c:v>207.30032162958977</c:v>
                </c:pt>
              </c:numCache>
            </c:numRef>
          </c:val>
          <c:extLst>
            <c:ext xmlns:c15="http://schemas.microsoft.com/office/drawing/2012/chart" uri="{02D57815-91ED-43cb-92C2-25804820EDAC}">
              <c15:datalabelsRange>
                <c15:f>'Plate 1 - Sheet1'!$O$89:$O$91</c15:f>
                <c15:dlblRangeCache>
                  <c:ptCount val="3"/>
                  <c:pt idx="0">
                    <c:v>a</c:v>
                  </c:pt>
                  <c:pt idx="1">
                    <c:v>a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03-B8F1-4717-984B-74820E3DE1C0}"/>
            </c:ext>
          </c:extLst>
        </c:ser>
        <c:ser>
          <c:idx val="1"/>
          <c:order val="1"/>
          <c:tx>
            <c:strRef>
              <c:f>'Plate 1 - Sheet1'!$L$88</c:f>
              <c:strCache>
                <c:ptCount val="1"/>
                <c:pt idx="0">
                  <c:v>BER-affected fruit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Lbls>
            <c:dLbl>
              <c:idx val="0"/>
              <c:layout>
                <c:manualLayout>
                  <c:x val="-3.8743040924084554E-17"/>
                  <c:y val="-4.2393956691402036E-2"/>
                </c:manualLayout>
              </c:layout>
              <c:tx>
                <c:rich>
                  <a:bodyPr/>
                  <a:lstStyle/>
                  <a:p>
                    <a:fld id="{1D825043-C939-42B6-92CC-9CA80C8E9492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4-B8F1-4717-984B-74820E3DE1C0}"/>
                </c:ext>
              </c:extLst>
            </c:dLbl>
            <c:dLbl>
              <c:idx val="1"/>
              <c:layout>
                <c:manualLayout>
                  <c:x val="7.7486081848169108E-17"/>
                  <c:y val="-8.9027309051944281E-2"/>
                </c:manualLayout>
              </c:layout>
              <c:tx>
                <c:rich>
                  <a:bodyPr/>
                  <a:lstStyle/>
                  <a:p>
                    <a:fld id="{A865ABC1-82A3-4ECC-858D-577C5204BF3C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5-B8F1-4717-984B-74820E3DE1C0}"/>
                </c:ext>
              </c:extLst>
            </c:dLbl>
            <c:dLbl>
              <c:idx val="2"/>
              <c:layout>
                <c:manualLayout>
                  <c:x val="2.1132811901998115E-3"/>
                  <c:y val="-0.25436374014841223"/>
                </c:manualLayout>
              </c:layout>
              <c:tx>
                <c:rich>
                  <a:bodyPr/>
                  <a:lstStyle/>
                  <a:p>
                    <a:fld id="{C191474F-CED6-4663-9FF6-255C3AD46635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6-B8F1-4717-984B-74820E3DE1C0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Plate 1 - Sheet1'!$N$89:$N$91</c:f>
                <c:numCache>
                  <c:formatCode>General</c:formatCode>
                  <c:ptCount val="3"/>
                  <c:pt idx="0">
                    <c:v>96.230277515043213</c:v>
                  </c:pt>
                  <c:pt idx="1">
                    <c:v>178.64493060499325</c:v>
                  </c:pt>
                  <c:pt idx="2">
                    <c:v>464.20084196533884</c:v>
                  </c:pt>
                </c:numCache>
              </c:numRef>
            </c:plus>
            <c:minus>
              <c:numRef>
                <c:f>'Plate 1 - Sheet1'!$N$89:$N$91</c:f>
                <c:numCache>
                  <c:formatCode>General</c:formatCode>
                  <c:ptCount val="3"/>
                  <c:pt idx="0">
                    <c:v>96.230277515043213</c:v>
                  </c:pt>
                  <c:pt idx="1">
                    <c:v>178.64493060499325</c:v>
                  </c:pt>
                  <c:pt idx="2">
                    <c:v>464.2008419653388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Plate 1 - Sheet1'!$L$89:$L$91</c:f>
              <c:numCache>
                <c:formatCode>General</c:formatCode>
                <c:ptCount val="3"/>
                <c:pt idx="0">
                  <c:v>125.63655856338778</c:v>
                </c:pt>
                <c:pt idx="1">
                  <c:v>316.18533905119244</c:v>
                </c:pt>
                <c:pt idx="2">
                  <c:v>898.30139372822327</c:v>
                </c:pt>
              </c:numCache>
            </c:numRef>
          </c:val>
          <c:extLst>
            <c:ext xmlns:c15="http://schemas.microsoft.com/office/drawing/2012/chart" uri="{02D57815-91ED-43cb-92C2-25804820EDAC}">
              <c15:datalabelsRange>
                <c15:f>'Plate 1 - Sheet1'!$P$89:$P$91</c15:f>
                <c15:dlblRangeCache>
                  <c:ptCount val="3"/>
                  <c:pt idx="0">
                    <c:v>a</c:v>
                  </c:pt>
                  <c:pt idx="1">
                    <c:v>a</c:v>
                  </c:pt>
                  <c:pt idx="2">
                    <c:v>b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07-B8F1-4717-984B-74820E3DE1C0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50"/>
        <c:axId val="417004816"/>
        <c:axId val="417004160"/>
      </c:barChart>
      <c:catAx>
        <c:axId val="4170048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17004160"/>
        <c:crosses val="autoZero"/>
        <c:auto val="1"/>
        <c:lblAlgn val="ctr"/>
        <c:lblOffset val="100"/>
        <c:noMultiLvlLbl val="0"/>
      </c:catAx>
      <c:valAx>
        <c:axId val="4170041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 err="1"/>
                  <a:t>nmol</a:t>
                </a:r>
                <a:r>
                  <a:rPr lang="en-US" dirty="0"/>
                  <a:t> min</a:t>
                </a:r>
                <a:r>
                  <a:rPr lang="en-US" baseline="30000" dirty="0"/>
                  <a:t>-1</a:t>
                </a:r>
                <a:r>
                  <a:rPr lang="en-US" dirty="0"/>
                  <a:t> g FW</a:t>
                </a:r>
                <a:r>
                  <a:rPr lang="en-US" baseline="30000" dirty="0"/>
                  <a:t>-1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17004816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r"/>
      <c:layout>
        <c:manualLayout>
          <c:xMode val="edge"/>
          <c:yMode val="edge"/>
          <c:x val="0.11547634023627482"/>
          <c:y val="5.31717827147919E-2"/>
          <c:w val="0.30830597500016199"/>
          <c:h val="0.2236034412353193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600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88541" y="247596"/>
            <a:ext cx="2331244" cy="526709"/>
          </a:xfrm>
        </p:spPr>
        <p:txBody>
          <a:bodyPr anchor="b"/>
          <a:lstStyle>
            <a:lvl1pPr algn="ctr">
              <a:defRPr sz="132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88541" y="794617"/>
            <a:ext cx="2331244" cy="365264"/>
          </a:xfrm>
        </p:spPr>
        <p:txBody>
          <a:bodyPr/>
          <a:lstStyle>
            <a:lvl1pPr marL="0" indent="0" algn="ctr">
              <a:buNone/>
              <a:defRPr sz="529"/>
            </a:lvl1pPr>
            <a:lvl2pPr marL="100858" indent="0" algn="ctr">
              <a:buNone/>
              <a:defRPr sz="441"/>
            </a:lvl2pPr>
            <a:lvl3pPr marL="201717" indent="0" algn="ctr">
              <a:buNone/>
              <a:defRPr sz="397"/>
            </a:lvl3pPr>
            <a:lvl4pPr marL="302575" indent="0" algn="ctr">
              <a:buNone/>
              <a:defRPr sz="353"/>
            </a:lvl4pPr>
            <a:lvl5pPr marL="403433" indent="0" algn="ctr">
              <a:buNone/>
              <a:defRPr sz="353"/>
            </a:lvl5pPr>
            <a:lvl6pPr marL="504292" indent="0" algn="ctr">
              <a:buNone/>
              <a:defRPr sz="353"/>
            </a:lvl6pPr>
            <a:lvl7pPr marL="605150" indent="0" algn="ctr">
              <a:buNone/>
              <a:defRPr sz="353"/>
            </a:lvl7pPr>
            <a:lvl8pPr marL="706008" indent="0" algn="ctr">
              <a:buNone/>
              <a:defRPr sz="353"/>
            </a:lvl8pPr>
            <a:lvl9pPr marL="806867" indent="0" algn="ctr">
              <a:buNone/>
              <a:defRPr sz="35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62CCA-BEE0-46EF-9A2D-CDD523FD80BB}" type="datetimeFigureOut">
              <a:rPr lang="en-US" smtClean="0"/>
              <a:t>2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4F416-B2C6-468B-A2B4-DE403A7C78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80885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62CCA-BEE0-46EF-9A2D-CDD523FD80BB}" type="datetimeFigureOut">
              <a:rPr lang="en-US" smtClean="0"/>
              <a:t>2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4F416-B2C6-468B-A2B4-DE403A7C78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71989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224395" y="80547"/>
            <a:ext cx="670233" cy="12821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13697" y="80547"/>
            <a:ext cx="1971844" cy="128210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62CCA-BEE0-46EF-9A2D-CDD523FD80BB}" type="datetimeFigureOut">
              <a:rPr lang="en-US" smtClean="0"/>
              <a:t>2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4F416-B2C6-468B-A2B4-DE403A7C78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05178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62CCA-BEE0-46EF-9A2D-CDD523FD80BB}" type="datetimeFigureOut">
              <a:rPr lang="en-US" smtClean="0"/>
              <a:t>2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4F416-B2C6-468B-A2B4-DE403A7C78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6552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2079" y="377172"/>
            <a:ext cx="2680930" cy="629319"/>
          </a:xfrm>
        </p:spPr>
        <p:txBody>
          <a:bodyPr anchor="b"/>
          <a:lstStyle>
            <a:lvl1pPr>
              <a:defRPr sz="132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2079" y="1012445"/>
            <a:ext cx="2680930" cy="330944"/>
          </a:xfrm>
        </p:spPr>
        <p:txBody>
          <a:bodyPr/>
          <a:lstStyle>
            <a:lvl1pPr marL="0" indent="0">
              <a:buNone/>
              <a:defRPr sz="529">
                <a:solidFill>
                  <a:schemeClr val="tx1">
                    <a:tint val="75000"/>
                  </a:schemeClr>
                </a:solidFill>
              </a:defRPr>
            </a:lvl1pPr>
            <a:lvl2pPr marL="100858" indent="0">
              <a:buNone/>
              <a:defRPr sz="441">
                <a:solidFill>
                  <a:schemeClr val="tx1">
                    <a:tint val="75000"/>
                  </a:schemeClr>
                </a:solidFill>
              </a:defRPr>
            </a:lvl2pPr>
            <a:lvl3pPr marL="201717" indent="0">
              <a:buNone/>
              <a:defRPr sz="397">
                <a:solidFill>
                  <a:schemeClr val="tx1">
                    <a:tint val="75000"/>
                  </a:schemeClr>
                </a:solidFill>
              </a:defRPr>
            </a:lvl3pPr>
            <a:lvl4pPr marL="302575" indent="0">
              <a:buNone/>
              <a:defRPr sz="353">
                <a:solidFill>
                  <a:schemeClr val="tx1">
                    <a:tint val="75000"/>
                  </a:schemeClr>
                </a:solidFill>
              </a:defRPr>
            </a:lvl4pPr>
            <a:lvl5pPr marL="403433" indent="0">
              <a:buNone/>
              <a:defRPr sz="353">
                <a:solidFill>
                  <a:schemeClr val="tx1">
                    <a:tint val="75000"/>
                  </a:schemeClr>
                </a:solidFill>
              </a:defRPr>
            </a:lvl5pPr>
            <a:lvl6pPr marL="504292" indent="0">
              <a:buNone/>
              <a:defRPr sz="353">
                <a:solidFill>
                  <a:schemeClr val="tx1">
                    <a:tint val="75000"/>
                  </a:schemeClr>
                </a:solidFill>
              </a:defRPr>
            </a:lvl6pPr>
            <a:lvl7pPr marL="605150" indent="0">
              <a:buNone/>
              <a:defRPr sz="353">
                <a:solidFill>
                  <a:schemeClr val="tx1">
                    <a:tint val="75000"/>
                  </a:schemeClr>
                </a:solidFill>
              </a:defRPr>
            </a:lvl7pPr>
            <a:lvl8pPr marL="706008" indent="0">
              <a:buNone/>
              <a:defRPr sz="353">
                <a:solidFill>
                  <a:schemeClr val="tx1">
                    <a:tint val="75000"/>
                  </a:schemeClr>
                </a:solidFill>
              </a:defRPr>
            </a:lvl8pPr>
            <a:lvl9pPr marL="806867" indent="0">
              <a:buNone/>
              <a:defRPr sz="35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62CCA-BEE0-46EF-9A2D-CDD523FD80BB}" type="datetimeFigureOut">
              <a:rPr lang="en-US" smtClean="0"/>
              <a:t>2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4F416-B2C6-468B-A2B4-DE403A7C78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8844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13697" y="402736"/>
            <a:ext cx="1321038" cy="95991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73590" y="402736"/>
            <a:ext cx="1321038" cy="95991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62CCA-BEE0-46EF-9A2D-CDD523FD80BB}" type="datetimeFigureOut">
              <a:rPr lang="en-US" smtClean="0"/>
              <a:t>2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4F416-B2C6-468B-A2B4-DE403A7C78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97135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4102" y="80547"/>
            <a:ext cx="2680930" cy="29242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4102" y="370868"/>
            <a:ext cx="1314967" cy="181757"/>
          </a:xfrm>
        </p:spPr>
        <p:txBody>
          <a:bodyPr anchor="b"/>
          <a:lstStyle>
            <a:lvl1pPr marL="0" indent="0">
              <a:buNone/>
              <a:defRPr sz="529" b="1"/>
            </a:lvl1pPr>
            <a:lvl2pPr marL="100858" indent="0">
              <a:buNone/>
              <a:defRPr sz="441" b="1"/>
            </a:lvl2pPr>
            <a:lvl3pPr marL="201717" indent="0">
              <a:buNone/>
              <a:defRPr sz="397" b="1"/>
            </a:lvl3pPr>
            <a:lvl4pPr marL="302575" indent="0">
              <a:buNone/>
              <a:defRPr sz="353" b="1"/>
            </a:lvl4pPr>
            <a:lvl5pPr marL="403433" indent="0">
              <a:buNone/>
              <a:defRPr sz="353" b="1"/>
            </a:lvl5pPr>
            <a:lvl6pPr marL="504292" indent="0">
              <a:buNone/>
              <a:defRPr sz="353" b="1"/>
            </a:lvl6pPr>
            <a:lvl7pPr marL="605150" indent="0">
              <a:buNone/>
              <a:defRPr sz="353" b="1"/>
            </a:lvl7pPr>
            <a:lvl8pPr marL="706008" indent="0">
              <a:buNone/>
              <a:defRPr sz="353" b="1"/>
            </a:lvl8pPr>
            <a:lvl9pPr marL="806867" indent="0">
              <a:buNone/>
              <a:defRPr sz="35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14102" y="552624"/>
            <a:ext cx="1314967" cy="81282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573590" y="370868"/>
            <a:ext cx="1321443" cy="181757"/>
          </a:xfrm>
        </p:spPr>
        <p:txBody>
          <a:bodyPr anchor="b"/>
          <a:lstStyle>
            <a:lvl1pPr marL="0" indent="0">
              <a:buNone/>
              <a:defRPr sz="529" b="1"/>
            </a:lvl1pPr>
            <a:lvl2pPr marL="100858" indent="0">
              <a:buNone/>
              <a:defRPr sz="441" b="1"/>
            </a:lvl2pPr>
            <a:lvl3pPr marL="201717" indent="0">
              <a:buNone/>
              <a:defRPr sz="397" b="1"/>
            </a:lvl3pPr>
            <a:lvl4pPr marL="302575" indent="0">
              <a:buNone/>
              <a:defRPr sz="353" b="1"/>
            </a:lvl4pPr>
            <a:lvl5pPr marL="403433" indent="0">
              <a:buNone/>
              <a:defRPr sz="353" b="1"/>
            </a:lvl5pPr>
            <a:lvl6pPr marL="504292" indent="0">
              <a:buNone/>
              <a:defRPr sz="353" b="1"/>
            </a:lvl6pPr>
            <a:lvl7pPr marL="605150" indent="0">
              <a:buNone/>
              <a:defRPr sz="353" b="1"/>
            </a:lvl7pPr>
            <a:lvl8pPr marL="706008" indent="0">
              <a:buNone/>
              <a:defRPr sz="353" b="1"/>
            </a:lvl8pPr>
            <a:lvl9pPr marL="806867" indent="0">
              <a:buNone/>
              <a:defRPr sz="35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573590" y="552624"/>
            <a:ext cx="1321443" cy="81282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62CCA-BEE0-46EF-9A2D-CDD523FD80BB}" type="datetimeFigureOut">
              <a:rPr lang="en-US" smtClean="0"/>
              <a:t>2/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4F416-B2C6-468B-A2B4-DE403A7C78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81361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62CCA-BEE0-46EF-9A2D-CDD523FD80BB}" type="datetimeFigureOut">
              <a:rPr lang="en-US" smtClean="0"/>
              <a:t>2/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4F416-B2C6-468B-A2B4-DE403A7C78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27753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62CCA-BEE0-46EF-9A2D-CDD523FD80BB}" type="datetimeFigureOut">
              <a:rPr lang="en-US" smtClean="0"/>
              <a:t>2/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4F416-B2C6-468B-A2B4-DE403A7C78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89778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4102" y="100859"/>
            <a:ext cx="1002516" cy="353007"/>
          </a:xfrm>
        </p:spPr>
        <p:txBody>
          <a:bodyPr anchor="b"/>
          <a:lstStyle>
            <a:lvl1pPr>
              <a:defRPr sz="70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321443" y="217828"/>
            <a:ext cx="1573590" cy="1075131"/>
          </a:xfrm>
        </p:spPr>
        <p:txBody>
          <a:bodyPr/>
          <a:lstStyle>
            <a:lvl1pPr>
              <a:defRPr sz="706"/>
            </a:lvl1pPr>
            <a:lvl2pPr>
              <a:defRPr sz="618"/>
            </a:lvl2pPr>
            <a:lvl3pPr>
              <a:defRPr sz="529"/>
            </a:lvl3pPr>
            <a:lvl4pPr>
              <a:defRPr sz="441"/>
            </a:lvl4pPr>
            <a:lvl5pPr>
              <a:defRPr sz="441"/>
            </a:lvl5pPr>
            <a:lvl6pPr>
              <a:defRPr sz="441"/>
            </a:lvl6pPr>
            <a:lvl7pPr>
              <a:defRPr sz="441"/>
            </a:lvl7pPr>
            <a:lvl8pPr>
              <a:defRPr sz="441"/>
            </a:lvl8pPr>
            <a:lvl9pPr>
              <a:defRPr sz="441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4102" y="453866"/>
            <a:ext cx="1002516" cy="840844"/>
          </a:xfrm>
        </p:spPr>
        <p:txBody>
          <a:bodyPr/>
          <a:lstStyle>
            <a:lvl1pPr marL="0" indent="0">
              <a:buNone/>
              <a:defRPr sz="353"/>
            </a:lvl1pPr>
            <a:lvl2pPr marL="100858" indent="0">
              <a:buNone/>
              <a:defRPr sz="309"/>
            </a:lvl2pPr>
            <a:lvl3pPr marL="201717" indent="0">
              <a:buNone/>
              <a:defRPr sz="265"/>
            </a:lvl3pPr>
            <a:lvl4pPr marL="302575" indent="0">
              <a:buNone/>
              <a:defRPr sz="221"/>
            </a:lvl4pPr>
            <a:lvl5pPr marL="403433" indent="0">
              <a:buNone/>
              <a:defRPr sz="221"/>
            </a:lvl5pPr>
            <a:lvl6pPr marL="504292" indent="0">
              <a:buNone/>
              <a:defRPr sz="221"/>
            </a:lvl6pPr>
            <a:lvl7pPr marL="605150" indent="0">
              <a:buNone/>
              <a:defRPr sz="221"/>
            </a:lvl7pPr>
            <a:lvl8pPr marL="706008" indent="0">
              <a:buNone/>
              <a:defRPr sz="221"/>
            </a:lvl8pPr>
            <a:lvl9pPr marL="806867" indent="0">
              <a:buNone/>
              <a:defRPr sz="22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62CCA-BEE0-46EF-9A2D-CDD523FD80BB}" type="datetimeFigureOut">
              <a:rPr lang="en-US" smtClean="0"/>
              <a:t>2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4F416-B2C6-468B-A2B4-DE403A7C78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87819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4102" y="100859"/>
            <a:ext cx="1002516" cy="353007"/>
          </a:xfrm>
        </p:spPr>
        <p:txBody>
          <a:bodyPr anchor="b"/>
          <a:lstStyle>
            <a:lvl1pPr>
              <a:defRPr sz="70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321443" y="217828"/>
            <a:ext cx="1573590" cy="1075131"/>
          </a:xfrm>
        </p:spPr>
        <p:txBody>
          <a:bodyPr anchor="t"/>
          <a:lstStyle>
            <a:lvl1pPr marL="0" indent="0">
              <a:buNone/>
              <a:defRPr sz="706"/>
            </a:lvl1pPr>
            <a:lvl2pPr marL="100858" indent="0">
              <a:buNone/>
              <a:defRPr sz="618"/>
            </a:lvl2pPr>
            <a:lvl3pPr marL="201717" indent="0">
              <a:buNone/>
              <a:defRPr sz="529"/>
            </a:lvl3pPr>
            <a:lvl4pPr marL="302575" indent="0">
              <a:buNone/>
              <a:defRPr sz="441"/>
            </a:lvl4pPr>
            <a:lvl5pPr marL="403433" indent="0">
              <a:buNone/>
              <a:defRPr sz="441"/>
            </a:lvl5pPr>
            <a:lvl6pPr marL="504292" indent="0">
              <a:buNone/>
              <a:defRPr sz="441"/>
            </a:lvl6pPr>
            <a:lvl7pPr marL="605150" indent="0">
              <a:buNone/>
              <a:defRPr sz="441"/>
            </a:lvl7pPr>
            <a:lvl8pPr marL="706008" indent="0">
              <a:buNone/>
              <a:defRPr sz="441"/>
            </a:lvl8pPr>
            <a:lvl9pPr marL="806867" indent="0">
              <a:buNone/>
              <a:defRPr sz="441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4102" y="453866"/>
            <a:ext cx="1002516" cy="840844"/>
          </a:xfrm>
        </p:spPr>
        <p:txBody>
          <a:bodyPr/>
          <a:lstStyle>
            <a:lvl1pPr marL="0" indent="0">
              <a:buNone/>
              <a:defRPr sz="353"/>
            </a:lvl1pPr>
            <a:lvl2pPr marL="100858" indent="0">
              <a:buNone/>
              <a:defRPr sz="309"/>
            </a:lvl2pPr>
            <a:lvl3pPr marL="201717" indent="0">
              <a:buNone/>
              <a:defRPr sz="265"/>
            </a:lvl3pPr>
            <a:lvl4pPr marL="302575" indent="0">
              <a:buNone/>
              <a:defRPr sz="221"/>
            </a:lvl4pPr>
            <a:lvl5pPr marL="403433" indent="0">
              <a:buNone/>
              <a:defRPr sz="221"/>
            </a:lvl5pPr>
            <a:lvl6pPr marL="504292" indent="0">
              <a:buNone/>
              <a:defRPr sz="221"/>
            </a:lvl6pPr>
            <a:lvl7pPr marL="605150" indent="0">
              <a:buNone/>
              <a:defRPr sz="221"/>
            </a:lvl7pPr>
            <a:lvl8pPr marL="706008" indent="0">
              <a:buNone/>
              <a:defRPr sz="221"/>
            </a:lvl8pPr>
            <a:lvl9pPr marL="806867" indent="0">
              <a:buNone/>
              <a:defRPr sz="22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62CCA-BEE0-46EF-9A2D-CDD523FD80BB}" type="datetimeFigureOut">
              <a:rPr lang="en-US" smtClean="0"/>
              <a:t>2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4F416-B2C6-468B-A2B4-DE403A7C78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138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13698" y="80547"/>
            <a:ext cx="2680930" cy="29242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3698" y="402736"/>
            <a:ext cx="2680930" cy="95991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13697" y="1402223"/>
            <a:ext cx="699373" cy="805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6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C62CCA-BEE0-46EF-9A2D-CDD523FD80BB}" type="datetimeFigureOut">
              <a:rPr lang="en-US" smtClean="0"/>
              <a:t>2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29633" y="1402223"/>
            <a:ext cx="1049060" cy="805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6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195255" y="1402223"/>
            <a:ext cx="699373" cy="805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6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24F416-B2C6-468B-A2B4-DE403A7C78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05316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201717" rtl="0" eaLnBrk="1" latinLnBrk="0" hangingPunct="1">
        <a:lnSpc>
          <a:spcPct val="90000"/>
        </a:lnSpc>
        <a:spcBef>
          <a:spcPct val="0"/>
        </a:spcBef>
        <a:buNone/>
        <a:defRPr sz="97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0429" indent="-50429" algn="l" defTabSz="201717" rtl="0" eaLnBrk="1" latinLnBrk="0" hangingPunct="1">
        <a:lnSpc>
          <a:spcPct val="90000"/>
        </a:lnSpc>
        <a:spcBef>
          <a:spcPts val="221"/>
        </a:spcBef>
        <a:buFont typeface="Arial" panose="020B0604020202020204" pitchFamily="34" charset="0"/>
        <a:buChar char="•"/>
        <a:defRPr sz="618" kern="1200">
          <a:solidFill>
            <a:schemeClr val="tx1"/>
          </a:solidFill>
          <a:latin typeface="+mn-lt"/>
          <a:ea typeface="+mn-ea"/>
          <a:cs typeface="+mn-cs"/>
        </a:defRPr>
      </a:lvl1pPr>
      <a:lvl2pPr marL="151287" indent="-50429" algn="l" defTabSz="201717" rtl="0" eaLnBrk="1" latinLnBrk="0" hangingPunct="1">
        <a:lnSpc>
          <a:spcPct val="90000"/>
        </a:lnSpc>
        <a:spcBef>
          <a:spcPts val="110"/>
        </a:spcBef>
        <a:buFont typeface="Arial" panose="020B0604020202020204" pitchFamily="34" charset="0"/>
        <a:buChar char="•"/>
        <a:defRPr sz="529" kern="1200">
          <a:solidFill>
            <a:schemeClr val="tx1"/>
          </a:solidFill>
          <a:latin typeface="+mn-lt"/>
          <a:ea typeface="+mn-ea"/>
          <a:cs typeface="+mn-cs"/>
        </a:defRPr>
      </a:lvl2pPr>
      <a:lvl3pPr marL="252146" indent="-50429" algn="l" defTabSz="201717" rtl="0" eaLnBrk="1" latinLnBrk="0" hangingPunct="1">
        <a:lnSpc>
          <a:spcPct val="90000"/>
        </a:lnSpc>
        <a:spcBef>
          <a:spcPts val="110"/>
        </a:spcBef>
        <a:buFont typeface="Arial" panose="020B0604020202020204" pitchFamily="34" charset="0"/>
        <a:buChar char="•"/>
        <a:defRPr sz="441" kern="1200">
          <a:solidFill>
            <a:schemeClr val="tx1"/>
          </a:solidFill>
          <a:latin typeface="+mn-lt"/>
          <a:ea typeface="+mn-ea"/>
          <a:cs typeface="+mn-cs"/>
        </a:defRPr>
      </a:lvl3pPr>
      <a:lvl4pPr marL="353004" indent="-50429" algn="l" defTabSz="201717" rtl="0" eaLnBrk="1" latinLnBrk="0" hangingPunct="1">
        <a:lnSpc>
          <a:spcPct val="90000"/>
        </a:lnSpc>
        <a:spcBef>
          <a:spcPts val="110"/>
        </a:spcBef>
        <a:buFont typeface="Arial" panose="020B0604020202020204" pitchFamily="34" charset="0"/>
        <a:buChar char="•"/>
        <a:defRPr sz="397" kern="1200">
          <a:solidFill>
            <a:schemeClr val="tx1"/>
          </a:solidFill>
          <a:latin typeface="+mn-lt"/>
          <a:ea typeface="+mn-ea"/>
          <a:cs typeface="+mn-cs"/>
        </a:defRPr>
      </a:lvl4pPr>
      <a:lvl5pPr marL="453862" indent="-50429" algn="l" defTabSz="201717" rtl="0" eaLnBrk="1" latinLnBrk="0" hangingPunct="1">
        <a:lnSpc>
          <a:spcPct val="90000"/>
        </a:lnSpc>
        <a:spcBef>
          <a:spcPts val="110"/>
        </a:spcBef>
        <a:buFont typeface="Arial" panose="020B0604020202020204" pitchFamily="34" charset="0"/>
        <a:buChar char="•"/>
        <a:defRPr sz="397" kern="1200">
          <a:solidFill>
            <a:schemeClr val="tx1"/>
          </a:solidFill>
          <a:latin typeface="+mn-lt"/>
          <a:ea typeface="+mn-ea"/>
          <a:cs typeface="+mn-cs"/>
        </a:defRPr>
      </a:lvl5pPr>
      <a:lvl6pPr marL="554721" indent="-50429" algn="l" defTabSz="201717" rtl="0" eaLnBrk="1" latinLnBrk="0" hangingPunct="1">
        <a:lnSpc>
          <a:spcPct val="90000"/>
        </a:lnSpc>
        <a:spcBef>
          <a:spcPts val="110"/>
        </a:spcBef>
        <a:buFont typeface="Arial" panose="020B0604020202020204" pitchFamily="34" charset="0"/>
        <a:buChar char="•"/>
        <a:defRPr sz="397" kern="1200">
          <a:solidFill>
            <a:schemeClr val="tx1"/>
          </a:solidFill>
          <a:latin typeface="+mn-lt"/>
          <a:ea typeface="+mn-ea"/>
          <a:cs typeface="+mn-cs"/>
        </a:defRPr>
      </a:lvl6pPr>
      <a:lvl7pPr marL="655579" indent="-50429" algn="l" defTabSz="201717" rtl="0" eaLnBrk="1" latinLnBrk="0" hangingPunct="1">
        <a:lnSpc>
          <a:spcPct val="90000"/>
        </a:lnSpc>
        <a:spcBef>
          <a:spcPts val="110"/>
        </a:spcBef>
        <a:buFont typeface="Arial" panose="020B0604020202020204" pitchFamily="34" charset="0"/>
        <a:buChar char="•"/>
        <a:defRPr sz="397" kern="1200">
          <a:solidFill>
            <a:schemeClr val="tx1"/>
          </a:solidFill>
          <a:latin typeface="+mn-lt"/>
          <a:ea typeface="+mn-ea"/>
          <a:cs typeface="+mn-cs"/>
        </a:defRPr>
      </a:lvl7pPr>
      <a:lvl8pPr marL="756437" indent="-50429" algn="l" defTabSz="201717" rtl="0" eaLnBrk="1" latinLnBrk="0" hangingPunct="1">
        <a:lnSpc>
          <a:spcPct val="90000"/>
        </a:lnSpc>
        <a:spcBef>
          <a:spcPts val="110"/>
        </a:spcBef>
        <a:buFont typeface="Arial" panose="020B0604020202020204" pitchFamily="34" charset="0"/>
        <a:buChar char="•"/>
        <a:defRPr sz="397" kern="1200">
          <a:solidFill>
            <a:schemeClr val="tx1"/>
          </a:solidFill>
          <a:latin typeface="+mn-lt"/>
          <a:ea typeface="+mn-ea"/>
          <a:cs typeface="+mn-cs"/>
        </a:defRPr>
      </a:lvl8pPr>
      <a:lvl9pPr marL="857296" indent="-50429" algn="l" defTabSz="201717" rtl="0" eaLnBrk="1" latinLnBrk="0" hangingPunct="1">
        <a:lnSpc>
          <a:spcPct val="90000"/>
        </a:lnSpc>
        <a:spcBef>
          <a:spcPts val="110"/>
        </a:spcBef>
        <a:buFont typeface="Arial" panose="020B0604020202020204" pitchFamily="34" charset="0"/>
        <a:buChar char="•"/>
        <a:defRPr sz="39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01717" rtl="0" eaLnBrk="1" latinLnBrk="0" hangingPunct="1">
        <a:defRPr sz="397" kern="1200">
          <a:solidFill>
            <a:schemeClr val="tx1"/>
          </a:solidFill>
          <a:latin typeface="+mn-lt"/>
          <a:ea typeface="+mn-ea"/>
          <a:cs typeface="+mn-cs"/>
        </a:defRPr>
      </a:lvl1pPr>
      <a:lvl2pPr marL="100858" algn="l" defTabSz="201717" rtl="0" eaLnBrk="1" latinLnBrk="0" hangingPunct="1">
        <a:defRPr sz="397" kern="1200">
          <a:solidFill>
            <a:schemeClr val="tx1"/>
          </a:solidFill>
          <a:latin typeface="+mn-lt"/>
          <a:ea typeface="+mn-ea"/>
          <a:cs typeface="+mn-cs"/>
        </a:defRPr>
      </a:lvl2pPr>
      <a:lvl3pPr marL="201717" algn="l" defTabSz="201717" rtl="0" eaLnBrk="1" latinLnBrk="0" hangingPunct="1">
        <a:defRPr sz="397" kern="1200">
          <a:solidFill>
            <a:schemeClr val="tx1"/>
          </a:solidFill>
          <a:latin typeface="+mn-lt"/>
          <a:ea typeface="+mn-ea"/>
          <a:cs typeface="+mn-cs"/>
        </a:defRPr>
      </a:lvl3pPr>
      <a:lvl4pPr marL="302575" algn="l" defTabSz="201717" rtl="0" eaLnBrk="1" latinLnBrk="0" hangingPunct="1">
        <a:defRPr sz="397" kern="1200">
          <a:solidFill>
            <a:schemeClr val="tx1"/>
          </a:solidFill>
          <a:latin typeface="+mn-lt"/>
          <a:ea typeface="+mn-ea"/>
          <a:cs typeface="+mn-cs"/>
        </a:defRPr>
      </a:lvl4pPr>
      <a:lvl5pPr marL="403433" algn="l" defTabSz="201717" rtl="0" eaLnBrk="1" latinLnBrk="0" hangingPunct="1">
        <a:defRPr sz="397" kern="1200">
          <a:solidFill>
            <a:schemeClr val="tx1"/>
          </a:solidFill>
          <a:latin typeface="+mn-lt"/>
          <a:ea typeface="+mn-ea"/>
          <a:cs typeface="+mn-cs"/>
        </a:defRPr>
      </a:lvl5pPr>
      <a:lvl6pPr marL="504292" algn="l" defTabSz="201717" rtl="0" eaLnBrk="1" latinLnBrk="0" hangingPunct="1">
        <a:defRPr sz="397" kern="1200">
          <a:solidFill>
            <a:schemeClr val="tx1"/>
          </a:solidFill>
          <a:latin typeface="+mn-lt"/>
          <a:ea typeface="+mn-ea"/>
          <a:cs typeface="+mn-cs"/>
        </a:defRPr>
      </a:lvl6pPr>
      <a:lvl7pPr marL="605150" algn="l" defTabSz="201717" rtl="0" eaLnBrk="1" latinLnBrk="0" hangingPunct="1">
        <a:defRPr sz="397" kern="1200">
          <a:solidFill>
            <a:schemeClr val="tx1"/>
          </a:solidFill>
          <a:latin typeface="+mn-lt"/>
          <a:ea typeface="+mn-ea"/>
          <a:cs typeface="+mn-cs"/>
        </a:defRPr>
      </a:lvl7pPr>
      <a:lvl8pPr marL="706008" algn="l" defTabSz="201717" rtl="0" eaLnBrk="1" latinLnBrk="0" hangingPunct="1">
        <a:defRPr sz="397" kern="1200">
          <a:solidFill>
            <a:schemeClr val="tx1"/>
          </a:solidFill>
          <a:latin typeface="+mn-lt"/>
          <a:ea typeface="+mn-ea"/>
          <a:cs typeface="+mn-cs"/>
        </a:defRPr>
      </a:lvl8pPr>
      <a:lvl9pPr marL="806867" algn="l" defTabSz="201717" rtl="0" eaLnBrk="1" latinLnBrk="0" hangingPunct="1">
        <a:defRPr sz="39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00000000-0008-0000-00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60659803"/>
              </p:ext>
            </p:extLst>
          </p:nvPr>
        </p:nvGraphicFramePr>
        <p:xfrm>
          <a:off x="-1" y="0"/>
          <a:ext cx="3108326" cy="15128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18049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5</TotalTime>
  <Words>9</Words>
  <Application>Microsoft Office PowerPoint</Application>
  <PresentationFormat>Custom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wner</dc:creator>
  <cp:lastModifiedBy>Nicholas Frederick Reitz</cp:lastModifiedBy>
  <cp:revision>10</cp:revision>
  <dcterms:created xsi:type="dcterms:W3CDTF">2020-04-17T22:09:51Z</dcterms:created>
  <dcterms:modified xsi:type="dcterms:W3CDTF">2021-02-07T20:38:53Z</dcterms:modified>
</cp:coreProperties>
</file>